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486" r:id="rId2"/>
  </p:sldIdLst>
  <p:sldSz cx="6858000" cy="9906000" type="A4"/>
  <p:notesSz cx="6858000" cy="9144000"/>
  <p:defaultTextStyle>
    <a:defPPr>
      <a:defRPr lang="ja-JP"/>
    </a:defPPr>
    <a:lvl1pPr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33" userDrawn="1">
          <p15:clr>
            <a:srgbClr val="A4A3A4"/>
          </p15:clr>
        </p15:guide>
        <p15:guide id="2" pos="240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00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68"/>
    <p:restoredTop sz="91721"/>
  </p:normalViewPr>
  <p:slideViewPr>
    <p:cSldViewPr snapToGrid="0" snapToObjects="1">
      <p:cViewPr varScale="1">
        <p:scale>
          <a:sx n="140" d="100"/>
          <a:sy n="140" d="100"/>
        </p:scale>
        <p:origin x="2792" y="208"/>
      </p:cViewPr>
      <p:guideLst>
        <p:guide orient="horz" pos="1033"/>
        <p:guide pos="2409"/>
      </p:guideLst>
    </p:cSldViewPr>
  </p:slideViewPr>
  <p:notesTextViewPr>
    <p:cViewPr>
      <p:scale>
        <a:sx n="110" d="100"/>
        <a:sy n="11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0422D198-30AD-A647-B7E3-ECFACE39D91A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504E4140-F544-DA4E-86A1-0893E88F18C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6134208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A7B7C74C-EECF-EB4C-9C57-8428B51BC34E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/>
              <a:t>マスター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0D0C2BB7-EC75-FB4C-B92D-6FE5951FA32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6887451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スライド イメージ プレースホルダー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241550" y="685800"/>
            <a:ext cx="237490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4578" name="ノート プレースホルダー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/>
              <a:t>17.6 vs 25.6% </a:t>
            </a:r>
          </a:p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/>
              <a:t>35.1% vs 17.4%</a:t>
            </a:r>
            <a:endParaRPr lang="ja-JP" altLang="en-US"/>
          </a:p>
          <a:p>
            <a:endParaRPr lang="en-US" altLang="ja-JP" dirty="0"/>
          </a:p>
        </p:txBody>
      </p:sp>
      <p:sp>
        <p:nvSpPr>
          <p:cNvPr id="24579" name="スライド番号プレースホルダー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fld id="{9874CDFF-8226-5B41-929D-CE6DE058CC8F}" type="slidenum">
              <a:rPr lang="ja-JP" altLang="en-US"/>
              <a:pPr/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034750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F76EBF-9398-2640-8DAB-997B13392099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DC99BF-DE4D-754E-9B3C-586642B6B9A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28930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BABE14-5AFA-C44C-895C-C83ADF92B366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C5911-3576-6C4F-8A9B-03040254D82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18593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A62886-623B-3749-99F6-BF8EFFFC3190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E2F037-7B4A-8241-ACBF-355CFEA7B2E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1328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4E2D8F-5E0E-EA42-8609-BE123053185C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E8BA53-6C2A-3A48-BED9-3AC3B44B05E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9717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F0AEB5-4DFB-E347-8AA6-343EEC578952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589894-EF02-4C4B-8C72-297CC18D4F5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35824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3E8FEA-2D03-B740-BD07-02CC7707A4CD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8DA93D-265A-A34C-B658-A24A36696DD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07609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CBAC04-D41C-7E43-A70E-D53B5DB280DF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A1490C-04CF-4F41-ACBD-FDEA45DBD0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04750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4E4A58-3A7F-1648-BFF6-95A6989B0DC4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BF5FD1-F64A-C840-B2F7-C26A0244A9F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98093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8118C7-C6B1-B84E-9E8A-57C646C83957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8491CD-DE18-914D-B10F-86E1114A3A0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1503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2C82E1-B7DF-D343-8167-8351F7419FF1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2855B4-B8B7-4649-BBF3-848BB151DED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82486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C121CB-8F33-B149-8656-A2B31915BCCE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80A47A-0478-3B4D-8CE8-A21E9991396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38635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342900" y="396699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342900" y="2311401"/>
            <a:ext cx="6172200" cy="6537502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9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A6A3542B-C1E7-E64E-8FF4-5B3F89E2295E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9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BA5FBAE5-B6FB-6144-BE3E-E6AC7E9D8BC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900" rtl="0" eaLnBrk="0" fontAlgn="base" hangingPunct="0">
        <a:spcBef>
          <a:spcPct val="0"/>
        </a:spcBef>
        <a:spcAft>
          <a:spcPct val="0"/>
        </a:spcAft>
        <a:defRPr kumimoji="1" sz="3300" kern="1200">
          <a:solidFill>
            <a:schemeClr val="tx1"/>
          </a:solidFill>
          <a:latin typeface="+mj-lt"/>
          <a:ea typeface="+mj-ea"/>
          <a:cs typeface="ＭＳ Ｐゴシック" charset="0"/>
        </a:defRPr>
      </a:lvl1pPr>
      <a:lvl2pPr algn="ctr" defTabSz="342900" rtl="0" eaLnBrk="0" fontAlgn="base" hangingPunct="0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2pPr>
      <a:lvl3pPr algn="ctr" defTabSz="342900" rtl="0" eaLnBrk="0" fontAlgn="base" hangingPunct="0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3pPr>
      <a:lvl4pPr algn="ctr" defTabSz="342900" rtl="0" eaLnBrk="0" fontAlgn="base" hangingPunct="0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4pPr>
      <a:lvl5pPr algn="ctr" defTabSz="342900" rtl="0" eaLnBrk="0" fontAlgn="base" hangingPunct="0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5pPr>
      <a:lvl6pPr marL="342900" algn="ctr" defTabSz="342900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6pPr>
      <a:lvl7pPr marL="685800" algn="ctr" defTabSz="342900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7pPr>
      <a:lvl8pPr marL="1028700" algn="ctr" defTabSz="342900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8pPr>
      <a:lvl9pPr marL="1371600" algn="ctr" defTabSz="342900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9pPr>
    </p:titleStyle>
    <p:bodyStyle>
      <a:lvl1pPr marL="257175" indent="-257175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557213" indent="-214313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4DBDB12B-F0D2-324F-A813-00079BEB11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5219" y="1612849"/>
            <a:ext cx="2795372" cy="1961665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E934CA16-F179-4B0D-EB04-2F3FF2C7931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55639" y="1612850"/>
            <a:ext cx="2811375" cy="1972895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62D1F8E-49FA-5506-9BC9-7A286A8B6218}"/>
              </a:ext>
            </a:extLst>
          </p:cNvPr>
          <p:cNvSpPr txBox="1"/>
          <p:nvPr/>
        </p:nvSpPr>
        <p:spPr>
          <a:xfrm>
            <a:off x="218807" y="106130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charset="0"/>
                <a:ea typeface="Arial" charset="0"/>
                <a:cs typeface="Arial" charset="0"/>
              </a:rPr>
              <a:t>a</a:t>
            </a:r>
            <a:endParaRPr kumimoji="1" lang="ja-JP" alt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DAFD979-8493-67FE-AF35-1E87D16785BC}"/>
              </a:ext>
            </a:extLst>
          </p:cNvPr>
          <p:cNvSpPr txBox="1"/>
          <p:nvPr/>
        </p:nvSpPr>
        <p:spPr>
          <a:xfrm>
            <a:off x="3455394" y="1058198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charset="0"/>
                <a:ea typeface="Arial" charset="0"/>
                <a:cs typeface="Arial" charset="0"/>
              </a:rPr>
              <a:t>b</a:t>
            </a:r>
            <a:endParaRPr kumimoji="1" lang="ja-JP" alt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60562DD-24B3-62EE-7AB8-F2B9ECD0974E}"/>
              </a:ext>
            </a:extLst>
          </p:cNvPr>
          <p:cNvSpPr txBox="1"/>
          <p:nvPr/>
        </p:nvSpPr>
        <p:spPr>
          <a:xfrm>
            <a:off x="519160" y="1080389"/>
            <a:ext cx="1337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older patients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23C8884-E2B9-623D-4A23-0FCDA2F72A5D}"/>
              </a:ext>
            </a:extLst>
          </p:cNvPr>
          <p:cNvSpPr txBox="1"/>
          <p:nvPr/>
        </p:nvSpPr>
        <p:spPr>
          <a:xfrm>
            <a:off x="3734638" y="1080389"/>
            <a:ext cx="1055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der patients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24">
            <a:extLst>
              <a:ext uri="{FF2B5EF4-FFF2-40B4-BE49-F238E27FC236}">
                <a16:creationId xmlns:a16="http://schemas.microsoft.com/office/drawing/2014/main" id="{EFEA460F-8350-454C-DB9D-82B1C48DE9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023" y="3454636"/>
            <a:ext cx="261675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charset="0"/>
                <a:ea typeface="Times New Roman" charset="0"/>
                <a:cs typeface="Times New Roman" charset="0"/>
              </a:rPr>
              <a:t>Time after surgery (years)</a:t>
            </a:r>
            <a:endParaRPr lang="ja-JP" altLang="en-US" sz="10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3" name="テキスト ボックス 9">
            <a:extLst>
              <a:ext uri="{FF2B5EF4-FFF2-40B4-BE49-F238E27FC236}">
                <a16:creationId xmlns:a16="http://schemas.microsoft.com/office/drawing/2014/main" id="{B161D28D-CB9C-D229-4388-36C2410B5C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3845" y="1579915"/>
            <a:ext cx="784226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=0.371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Log-rank</a:t>
            </a:r>
          </a:p>
        </p:txBody>
      </p:sp>
      <p:sp>
        <p:nvSpPr>
          <p:cNvPr id="35" name="テキスト ボックス 24">
            <a:extLst>
              <a:ext uri="{FF2B5EF4-FFF2-40B4-BE49-F238E27FC236}">
                <a16:creationId xmlns:a16="http://schemas.microsoft.com/office/drawing/2014/main" id="{980C6B4C-A3D4-9615-0B3F-262879696A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1273" y="3454636"/>
            <a:ext cx="261675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charset="0"/>
                <a:ea typeface="Times New Roman" charset="0"/>
                <a:cs typeface="Times New Roman" charset="0"/>
              </a:rPr>
              <a:t>Time after surgery (years)</a:t>
            </a:r>
            <a:endParaRPr lang="ja-JP" altLang="en-US" sz="10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6" name="テキスト ボックス 9">
            <a:extLst>
              <a:ext uri="{FF2B5EF4-FFF2-40B4-BE49-F238E27FC236}">
                <a16:creationId xmlns:a16="http://schemas.microsoft.com/office/drawing/2014/main" id="{1CF8417E-3D3E-BB6E-263A-E4C1908615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3392" y="1574043"/>
            <a:ext cx="759513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>
                <a:latin typeface="Times New Roman" charset="0"/>
                <a:ea typeface="Times New Roman" charset="0"/>
                <a:cs typeface="Times New Roman" charset="0"/>
              </a:rPr>
              <a:t>p=</a:t>
            </a: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0.113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Log-rank</a:t>
            </a:r>
          </a:p>
        </p:txBody>
      </p:sp>
      <p:sp>
        <p:nvSpPr>
          <p:cNvPr id="38" name="テキスト ボックス 12">
            <a:extLst>
              <a:ext uri="{FF2B5EF4-FFF2-40B4-BE49-F238E27FC236}">
                <a16:creationId xmlns:a16="http://schemas.microsoft.com/office/drawing/2014/main" id="{59877347-8989-2CDC-667D-6EF9C21C18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7596" y="2944114"/>
            <a:ext cx="15321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Complication (-): n=177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9" name="テキスト ボックス 12">
            <a:extLst>
              <a:ext uri="{FF2B5EF4-FFF2-40B4-BE49-F238E27FC236}">
                <a16:creationId xmlns:a16="http://schemas.microsoft.com/office/drawing/2014/main" id="{F659300A-5D05-3B21-5DB3-FD4AEC922E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7596" y="1924774"/>
            <a:ext cx="15321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Complication (+): n=14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0" name="テキスト ボックス 12">
            <a:extLst>
              <a:ext uri="{FF2B5EF4-FFF2-40B4-BE49-F238E27FC236}">
                <a16:creationId xmlns:a16="http://schemas.microsoft.com/office/drawing/2014/main" id="{141BEA5F-2120-BF8C-D830-5A02F59FA7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9250" y="3019316"/>
            <a:ext cx="15321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Complication (-): n=527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1" name="テキスト ボックス 12">
            <a:extLst>
              <a:ext uri="{FF2B5EF4-FFF2-40B4-BE49-F238E27FC236}">
                <a16:creationId xmlns:a16="http://schemas.microsoft.com/office/drawing/2014/main" id="{AC0EB6B8-6AD7-F61D-DA80-47E42DF853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11432" y="2318736"/>
            <a:ext cx="15321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Complication (+): n=43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6" name="テキスト ボックス 5">
            <a:extLst>
              <a:ext uri="{FF2B5EF4-FFF2-40B4-BE49-F238E27FC236}">
                <a16:creationId xmlns:a16="http://schemas.microsoft.com/office/drawing/2014/main" id="{25E47948-4945-7B17-5968-5CC8F4B6C414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3394862" y="1497738"/>
            <a:ext cx="369332" cy="1994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>
              <a:spcBef>
                <a:spcPct val="0"/>
              </a:spcBef>
              <a:buFont typeface="Arial" charset="0"/>
              <a:buNone/>
            </a:pPr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Cumulative incidence rate</a:t>
            </a:r>
          </a:p>
        </p:txBody>
      </p:sp>
      <p:sp>
        <p:nvSpPr>
          <p:cNvPr id="47" name="テキスト ボックス 5">
            <a:extLst>
              <a:ext uri="{FF2B5EF4-FFF2-40B4-BE49-F238E27FC236}">
                <a16:creationId xmlns:a16="http://schemas.microsoft.com/office/drawing/2014/main" id="{29138E83-EBC7-79C3-4284-5CBF380BDE39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149827" y="1497739"/>
            <a:ext cx="369332" cy="1994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>
              <a:spcBef>
                <a:spcPct val="0"/>
              </a:spcBef>
              <a:buFont typeface="Arial" charset="0"/>
              <a:buNone/>
            </a:pPr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Cumulative incidence rate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394A3BE-A38F-FA48-8455-D23ADABA61B5}"/>
              </a:ext>
            </a:extLst>
          </p:cNvPr>
          <p:cNvSpPr txBox="1"/>
          <p:nvPr/>
        </p:nvSpPr>
        <p:spPr>
          <a:xfrm>
            <a:off x="218807" y="316763"/>
            <a:ext cx="12458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43E139C-AEA9-A440-A3F6-CFEF02B27211}"/>
              </a:ext>
            </a:extLst>
          </p:cNvPr>
          <p:cNvSpPr txBox="1"/>
          <p:nvPr/>
        </p:nvSpPr>
        <p:spPr>
          <a:xfrm>
            <a:off x="195280" y="4992212"/>
            <a:ext cx="649224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le name: Additional file 2</a:t>
            </a:r>
          </a:p>
          <a:p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le format: PPTX</a:t>
            </a:r>
          </a:p>
          <a:p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 of data: Association between severe complications and cumulative recurrence rate. </a:t>
            </a:r>
          </a:p>
          <a:p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cription of data: (a) Estimated recurrence rates in non-older patients with and without severe postoperative complications. (b) Estimated recurrence rates in older patients with and without severe postoperative complications. </a:t>
            </a:r>
          </a:p>
        </p:txBody>
      </p:sp>
    </p:spTree>
    <p:extLst>
      <p:ext uri="{BB962C8B-B14F-4D97-AF65-F5344CB8AC3E}">
        <p14:creationId xmlns:p14="http://schemas.microsoft.com/office/powerpoint/2010/main" val="248333982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414</TotalTime>
  <Words>124</Words>
  <Application>Microsoft Macintosh PowerPoint</Application>
  <PresentationFormat>A4 210 x 297 mm</PresentationFormat>
  <Paragraphs>2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ホワイト</vt:lpstr>
      <vt:lpstr>PowerPoint プレゼンテーション</vt:lpstr>
    </vt:vector>
  </TitlesOfParts>
  <Company>Kyoto Prefectural University of Medicine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ogenous Factor in Development of Peritoneal Metastasis of Gastric Cancer</dc:title>
  <dc:creator>Arita Tomohiro</dc:creator>
  <cp:lastModifiedBy>松原大樹</cp:lastModifiedBy>
  <cp:revision>794</cp:revision>
  <cp:lastPrinted>2019-05-17T13:29:03Z</cp:lastPrinted>
  <dcterms:created xsi:type="dcterms:W3CDTF">2016-07-06T05:30:10Z</dcterms:created>
  <dcterms:modified xsi:type="dcterms:W3CDTF">2023-11-06T12:54:25Z</dcterms:modified>
</cp:coreProperties>
</file>